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92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897"/>
  </p:normalViewPr>
  <p:slideViewPr>
    <p:cSldViewPr snapToGrid="0" snapToObjects="1">
      <p:cViewPr varScale="1">
        <p:scale>
          <a:sx n="86" d="100"/>
          <a:sy n="86" d="100"/>
        </p:scale>
        <p:origin x="1147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AC8E-CDE8-6041-9ABE-6F660891EC1C}" type="datetimeFigureOut">
              <a:rPr lang="en-GB" smtClean="0"/>
              <a:t>07/0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44866E-A9A0-8146-B06A-4F937B946F1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63044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AC8E-CDE8-6041-9ABE-6F660891EC1C}" type="datetimeFigureOut">
              <a:rPr lang="en-GB" smtClean="0"/>
              <a:t>07/0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44866E-A9A0-8146-B06A-4F937B946F1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66099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AC8E-CDE8-6041-9ABE-6F660891EC1C}" type="datetimeFigureOut">
              <a:rPr lang="en-GB" smtClean="0"/>
              <a:t>07/0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44866E-A9A0-8146-B06A-4F937B946F1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52932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AC8E-CDE8-6041-9ABE-6F660891EC1C}" type="datetimeFigureOut">
              <a:rPr lang="en-GB" smtClean="0"/>
              <a:t>07/0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44866E-A9A0-8146-B06A-4F937B946F1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8284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AC8E-CDE8-6041-9ABE-6F660891EC1C}" type="datetimeFigureOut">
              <a:rPr lang="en-GB" smtClean="0"/>
              <a:t>07/0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44866E-A9A0-8146-B06A-4F937B946F1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71197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AC8E-CDE8-6041-9ABE-6F660891EC1C}" type="datetimeFigureOut">
              <a:rPr lang="en-GB" smtClean="0"/>
              <a:t>07/01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44866E-A9A0-8146-B06A-4F937B946F1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91770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AC8E-CDE8-6041-9ABE-6F660891EC1C}" type="datetimeFigureOut">
              <a:rPr lang="en-GB" smtClean="0"/>
              <a:t>07/01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44866E-A9A0-8146-B06A-4F937B946F1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18758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AC8E-CDE8-6041-9ABE-6F660891EC1C}" type="datetimeFigureOut">
              <a:rPr lang="en-GB" smtClean="0"/>
              <a:t>07/01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44866E-A9A0-8146-B06A-4F937B946F1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57463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AC8E-CDE8-6041-9ABE-6F660891EC1C}" type="datetimeFigureOut">
              <a:rPr lang="en-GB" smtClean="0"/>
              <a:t>07/01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44866E-A9A0-8146-B06A-4F937B946F1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37084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AC8E-CDE8-6041-9ABE-6F660891EC1C}" type="datetimeFigureOut">
              <a:rPr lang="en-GB" smtClean="0"/>
              <a:t>07/01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44866E-A9A0-8146-B06A-4F937B946F1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93063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5AC8E-CDE8-6041-9ABE-6F660891EC1C}" type="datetimeFigureOut">
              <a:rPr lang="en-GB" smtClean="0"/>
              <a:t>07/01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44866E-A9A0-8146-B06A-4F937B946F1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02373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D5AC8E-CDE8-6041-9ABE-6F660891EC1C}" type="datetimeFigureOut">
              <a:rPr lang="en-GB" smtClean="0"/>
              <a:t>07/0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44866E-A9A0-8146-B06A-4F937B946F1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84660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vpgnr82aes63h62l0d2eklrgs3(1)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560513" y="476672"/>
            <a:ext cx="6955429" cy="5216572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007837" y="107340"/>
            <a:ext cx="8208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Z stack through a </a:t>
            </a:r>
            <a:r>
              <a:rPr lang="en-GB" b="1" i="1" dirty="0"/>
              <a:t>C. albicans </a:t>
            </a:r>
            <a:r>
              <a:rPr lang="en-GB" b="1" dirty="0"/>
              <a:t>biofilm (2 µm depth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8218449" y="1988840"/>
            <a:ext cx="1572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 </a:t>
            </a:r>
            <a:r>
              <a:rPr lang="en-GB" sz="1600" b="1" dirty="0"/>
              <a:t>MET-Texas Red</a:t>
            </a:r>
          </a:p>
        </p:txBody>
      </p:sp>
      <p:cxnSp>
        <p:nvCxnSpPr>
          <p:cNvPr id="9" name="Straight Arrow Connector 8"/>
          <p:cNvCxnSpPr/>
          <p:nvPr/>
        </p:nvCxnSpPr>
        <p:spPr>
          <a:xfrm flipH="1">
            <a:off x="2029642" y="2173506"/>
            <a:ext cx="6510067" cy="2221304"/>
          </a:xfrm>
          <a:prstGeom prst="straightConnector1">
            <a:avLst/>
          </a:prstGeom>
          <a:ln>
            <a:solidFill>
              <a:srgbClr val="FFC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560513" y="6453336"/>
            <a:ext cx="86562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 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5440" y="6344677"/>
            <a:ext cx="882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Video S1: MET-Texas Red penetrated the biofilm and is seen bound to fungal cells.  </a:t>
            </a:r>
            <a:endParaRPr lang="en-GB" dirty="0"/>
          </a:p>
        </p:txBody>
      </p:sp>
      <p:cxnSp>
        <p:nvCxnSpPr>
          <p:cNvPr id="20" name="Straight Arrow Connector 19"/>
          <p:cNvCxnSpPr/>
          <p:nvPr/>
        </p:nvCxnSpPr>
        <p:spPr>
          <a:xfrm flipH="1">
            <a:off x="2648744" y="2173506"/>
            <a:ext cx="5890964" cy="2839670"/>
          </a:xfrm>
          <a:prstGeom prst="straightConnector1">
            <a:avLst/>
          </a:prstGeom>
          <a:ln>
            <a:solidFill>
              <a:srgbClr val="FFC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/>
          <p:cNvCxnSpPr/>
          <p:nvPr/>
        </p:nvCxnSpPr>
        <p:spPr>
          <a:xfrm flipH="1">
            <a:off x="7329264" y="5517232"/>
            <a:ext cx="792088" cy="0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8127229" y="5046243"/>
            <a:ext cx="14036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2060"/>
                </a:solidFill>
              </a:rPr>
              <a:t>Please click to see video</a:t>
            </a:r>
          </a:p>
        </p:txBody>
      </p:sp>
    </p:spTree>
    <p:extLst>
      <p:ext uri="{BB962C8B-B14F-4D97-AF65-F5344CB8AC3E}">
        <p14:creationId xmlns:p14="http://schemas.microsoft.com/office/powerpoint/2010/main" val="2723219209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3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4" fill="hold">
                      <p:stCondLst>
                        <p:cond delay="0"/>
                      </p:stCondLst>
                      <p:childTnLst>
                        <p:par>
                          <p:cTn id="5" fill="hold">
                            <p:stCondLst>
                              <p:cond delay="0"/>
                            </p:stCondLst>
                            <p:childTnLst>
                              <p:par>
                                <p:cTn id="6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7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2</TotalTime>
  <Words>38</Words>
  <Application>Microsoft Office PowerPoint</Application>
  <PresentationFormat>A4 Paper (210x297 mm)</PresentationFormat>
  <Paragraphs>5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uchegbu@gmail.com</dc:creator>
  <cp:lastModifiedBy>MDPI</cp:lastModifiedBy>
  <cp:revision>7</cp:revision>
  <dcterms:created xsi:type="dcterms:W3CDTF">2021-10-21T11:01:32Z</dcterms:created>
  <dcterms:modified xsi:type="dcterms:W3CDTF">2022-01-07T06:54:33Z</dcterms:modified>
</cp:coreProperties>
</file>